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2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CC"/>
    <a:srgbClr val="000099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8000" autoAdjust="0"/>
  </p:normalViewPr>
  <p:slideViewPr>
    <p:cSldViewPr snapToGrid="0" showGuides="1">
      <p:cViewPr varScale="1">
        <p:scale>
          <a:sx n="61" d="100"/>
          <a:sy n="61" d="100"/>
        </p:scale>
        <p:origin x="1020" y="66"/>
      </p:cViewPr>
      <p:guideLst>
        <p:guide orient="horz" pos="222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A18231-5ABE-49AB-A251-FA3C79B32ED2}" type="datetimeFigureOut">
              <a:rPr lang="it-IT" smtClean="0"/>
              <a:t>10/03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629DCA-84CC-4B37-BB6D-3F542093EA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3514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77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272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820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2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21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631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574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675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330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589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43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70070-9848-4659-931E-309E3223B41C}" type="datetimeFigureOut">
              <a:rPr lang="en-US" smtClean="0"/>
              <a:t>3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629D6-791F-4DA8-96EB-2217540CD42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030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4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3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2.png"/><Relationship Id="rId5" Type="http://schemas.microsoft.com/office/2007/relationships/media" Target="../media/media3.mp4"/><Relationship Id="rId10" Type="http://schemas.openxmlformats.org/officeDocument/2006/relationships/image" Target="../media/image1.png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370495" y="325164"/>
            <a:ext cx="114766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</a:t>
            </a:r>
            <a:r>
              <a:rPr lang="en-US" sz="2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(with movies).</a:t>
            </a:r>
            <a:r>
              <a:rPr lang="en-US" sz="2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rt movies showing the consistency of </a:t>
            </a:r>
            <a:r>
              <a:rPr lang="en-US" sz="2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</a:t>
            </a:r>
            <a:r>
              <a:rPr lang="en-US" sz="2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p. colonies isolated on </a:t>
            </a:r>
            <a:r>
              <a:rPr lang="en-US" sz="2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k</a:t>
            </a:r>
            <a:r>
              <a:rPr lang="en-US" sz="2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RS agar from human feces.</a:t>
            </a:r>
            <a:endParaRPr lang="en-US" sz="2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WhatsApp Video 2017-07-27 at 18.04.18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10"/>
          <a:srcRect l="33629" t="24999" r="43306" b="32140"/>
          <a:stretch/>
        </p:blipFill>
        <p:spPr>
          <a:xfrm>
            <a:off x="1475964" y="2378057"/>
            <a:ext cx="2512110" cy="2642603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5" name="CasellaDiTesto 4"/>
          <p:cNvSpPr txBox="1"/>
          <p:nvPr/>
        </p:nvSpPr>
        <p:spPr>
          <a:xfrm>
            <a:off x="370495" y="1708135"/>
            <a:ext cx="4723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82563" indent="-182563"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non-DG </a:t>
            </a:r>
            <a:r>
              <a:rPr lang="en-US" sz="1800" i="1" dirty="0">
                <a:latin typeface="Arial" panose="020B0604020202020204" pitchFamily="34" charset="0"/>
                <a:cs typeface="Arial" panose="020B0604020202020204" pitchFamily="34" charset="0"/>
              </a:rPr>
              <a:t>Lactobacillus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olonies on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vkMRS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6106629" y="1708135"/>
            <a:ext cx="48801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82563" indent="-182563" algn="ctr"/>
            <a:r>
              <a:rPr lang="en-US" sz="1800" i="1" dirty="0">
                <a:latin typeface="Arial" panose="020B0604020202020204" pitchFamily="34" charset="0"/>
                <a:cs typeface="Arial" panose="020B0604020202020204" pitchFamily="34" charset="0"/>
              </a:rPr>
              <a:t>L. paracasei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G colonies on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vkMRS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agar</a:t>
            </a:r>
          </a:p>
        </p:txBody>
      </p:sp>
      <p:pic>
        <p:nvPicPr>
          <p:cNvPr id="7" name="WhatsApp Video 2017-07-27 at 18.04.07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11"/>
          <a:srcRect l="31202" t="16304" r="46357" b="23475"/>
          <a:stretch/>
        </p:blipFill>
        <p:spPr>
          <a:xfrm>
            <a:off x="5962190" y="2378057"/>
            <a:ext cx="1752600" cy="2662455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8" name="WhatsApp Video 2017-07-27 at 18.04.00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2"/>
          <a:srcRect l="29484" r="46929" b="31297"/>
          <a:stretch/>
        </p:blipFill>
        <p:spPr>
          <a:xfrm>
            <a:off x="9971220" y="2385875"/>
            <a:ext cx="1600200" cy="263851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9" name="WhatsApp Video 2017-07-27 at 18.04.31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 rotWithShape="1">
          <a:blip r:embed="rId13"/>
          <a:srcRect l="38133" t="14756" r="34742" b="12679"/>
          <a:stretch/>
        </p:blipFill>
        <p:spPr>
          <a:xfrm>
            <a:off x="8000010" y="2378057"/>
            <a:ext cx="1752601" cy="2654151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13" name="CasellaDiTesto 12"/>
          <p:cNvSpPr txBox="1"/>
          <p:nvPr/>
        </p:nvSpPr>
        <p:spPr>
          <a:xfrm>
            <a:off x="1475964" y="5167361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ovie 1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5962190" y="5167360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ovie 2</a:t>
            </a:r>
          </a:p>
        </p:txBody>
      </p:sp>
      <p:sp>
        <p:nvSpPr>
          <p:cNvPr id="15" name="CasellaDiTesto 14"/>
          <p:cNvSpPr txBox="1"/>
          <p:nvPr/>
        </p:nvSpPr>
        <p:spPr>
          <a:xfrm>
            <a:off x="7961034" y="5167358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ovie 3</a:t>
            </a:r>
          </a:p>
        </p:txBody>
      </p:sp>
      <p:sp>
        <p:nvSpPr>
          <p:cNvPr id="16" name="CasellaDiTesto 15"/>
          <p:cNvSpPr txBox="1"/>
          <p:nvPr/>
        </p:nvSpPr>
        <p:spPr>
          <a:xfrm>
            <a:off x="9959879" y="5167358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i="1" dirty="0">
                <a:latin typeface="Arial" panose="020B0604020202020204" pitchFamily="34" charset="0"/>
                <a:cs typeface="Arial" panose="020B0604020202020204" pitchFamily="34" charset="0"/>
              </a:rPr>
              <a:t>Movie 4</a:t>
            </a:r>
          </a:p>
        </p:txBody>
      </p:sp>
    </p:spTree>
    <p:extLst>
      <p:ext uri="{BB962C8B-B14F-4D97-AF65-F5344CB8AC3E}">
        <p14:creationId xmlns:p14="http://schemas.microsoft.com/office/powerpoint/2010/main" val="21405485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 mute="1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 mute="1">
                <p:cTn id="13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seq concurrent="1" nextAc="seek">
              <p:cTn id="19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0" fill="hold">
                      <p:stCondLst>
                        <p:cond delay="0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3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 mute="1">
                <p:cTn id="24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video>
              <p:cMediaNode vol="80000" mute="1">
                <p:cTn id="25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94</TotalTime>
  <Words>46</Words>
  <Application>Microsoft Office PowerPoint</Application>
  <PresentationFormat>Widescreen</PresentationFormat>
  <Paragraphs>7</Paragraphs>
  <Slides>1</Slides>
  <Notes>0</Notes>
  <HiddenSlides>0</HiddenSlides>
  <MMClips>4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mone Guglielmetti</dc:creator>
  <cp:lastModifiedBy>Simone Guglielmetti</cp:lastModifiedBy>
  <cp:revision>59</cp:revision>
  <cp:lastPrinted>2018-01-08T18:16:22Z</cp:lastPrinted>
  <dcterms:created xsi:type="dcterms:W3CDTF">2017-07-14T23:35:24Z</dcterms:created>
  <dcterms:modified xsi:type="dcterms:W3CDTF">2018-03-10T12:03:43Z</dcterms:modified>
</cp:coreProperties>
</file>